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84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K$75:$K$77</c:f>
              <c:strCache>
                <c:ptCount val="3"/>
                <c:pt idx="0">
                  <c:v>8400-sc</c:v>
                </c:pt>
                <c:pt idx="1">
                  <c:v>8400-siFxn</c:v>
                </c:pt>
                <c:pt idx="2">
                  <c:v>8400-siFxn1+PCA 0.5µM</c:v>
                </c:pt>
              </c:strCache>
            </c:strRef>
          </c:cat>
          <c:val>
            <c:numRef>
              <c:f>Sheet1!$L$75:$L$77</c:f>
              <c:numCache>
                <c:formatCode>General</c:formatCode>
                <c:ptCount val="3"/>
              </c:numCache>
            </c:numRef>
          </c:val>
          <c:extLst>
            <c:ext xmlns:c16="http://schemas.microsoft.com/office/drawing/2014/chart" uri="{C3380CC4-5D6E-409C-BE32-E72D297353CC}">
              <c16:uniqueId val="{00000000-4B69-48B4-9848-8EC65546798B}"/>
            </c:ext>
          </c:extLst>
        </c:ser>
        <c:ser>
          <c:idx val="1"/>
          <c:order val="1"/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both"/>
            <c:errValType val="cust"/>
            <c:noEndCap val="0"/>
            <c:plus>
              <c:numRef>
                <c:f>Sheet1!$N$75:$N$77</c:f>
                <c:numCache>
                  <c:formatCode>General</c:formatCode>
                  <c:ptCount val="3"/>
                  <c:pt idx="0">
                    <c:v>4.1338550284752067</c:v>
                  </c:pt>
                  <c:pt idx="1">
                    <c:v>0.32635697593225216</c:v>
                  </c:pt>
                  <c:pt idx="2">
                    <c:v>0</c:v>
                  </c:pt>
                </c:numCache>
              </c:numRef>
            </c:plus>
            <c:minus>
              <c:numRef>
                <c:f>Sheet1!$N$75:$N$77</c:f>
                <c:numCache>
                  <c:formatCode>General</c:formatCode>
                  <c:ptCount val="3"/>
                  <c:pt idx="0">
                    <c:v>4.1338550284752067</c:v>
                  </c:pt>
                  <c:pt idx="1">
                    <c:v>0.32635697593225216</c:v>
                  </c:pt>
                  <c:pt idx="2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K$75:$K$77</c:f>
              <c:strCache>
                <c:ptCount val="3"/>
                <c:pt idx="0">
                  <c:v>8400-sc</c:v>
                </c:pt>
                <c:pt idx="1">
                  <c:v>8400-siFxn</c:v>
                </c:pt>
                <c:pt idx="2">
                  <c:v>8400-siFxn1+PCA 0.5µM</c:v>
                </c:pt>
              </c:strCache>
            </c:strRef>
          </c:cat>
          <c:val>
            <c:numRef>
              <c:f>Sheet1!$M$75:$M$77</c:f>
              <c:numCache>
                <c:formatCode>0.00</c:formatCode>
                <c:ptCount val="3"/>
                <c:pt idx="0">
                  <c:v>96.307692307692292</c:v>
                </c:pt>
                <c:pt idx="1">
                  <c:v>6.6923076923076916</c:v>
                </c:pt>
                <c:pt idx="2">
                  <c:v>6.76923076923076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B69-48B4-9848-8EC65546798B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1852768608"/>
        <c:axId val="1852774432"/>
      </c:barChart>
      <c:catAx>
        <c:axId val="18527686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52774432"/>
        <c:crosses val="autoZero"/>
        <c:auto val="1"/>
        <c:lblAlgn val="ctr"/>
        <c:lblOffset val="100"/>
        <c:noMultiLvlLbl val="0"/>
      </c:catAx>
      <c:valAx>
        <c:axId val="185277443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Fxn protein level (% control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527686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esults (2)'!$J$47:$J$49</c:f>
                <c:numCache>
                  <c:formatCode>General</c:formatCode>
                  <c:ptCount val="3"/>
                  <c:pt idx="0">
                    <c:v>4.6124552416909222E-2</c:v>
                  </c:pt>
                  <c:pt idx="1">
                    <c:v>7.4350177111286858E-2</c:v>
                  </c:pt>
                  <c:pt idx="2">
                    <c:v>8.8191821757127004E-2</c:v>
                  </c:pt>
                </c:numCache>
              </c:numRef>
            </c:plus>
            <c:minus>
              <c:numRef>
                <c:f>'Results (2)'!$J$47:$J$49</c:f>
                <c:numCache>
                  <c:formatCode>General</c:formatCode>
                  <c:ptCount val="3"/>
                  <c:pt idx="0">
                    <c:v>4.6124552416909222E-2</c:v>
                  </c:pt>
                  <c:pt idx="1">
                    <c:v>7.4350177111286858E-2</c:v>
                  </c:pt>
                  <c:pt idx="2">
                    <c:v>8.819182175712700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esults (2)'!$H$47:$H$49</c:f>
              <c:strCache>
                <c:ptCount val="3"/>
                <c:pt idx="0">
                  <c:v> CC</c:v>
                </c:pt>
                <c:pt idx="1">
                  <c:v>PCA 0.5µM</c:v>
                </c:pt>
                <c:pt idx="2">
                  <c:v>Omav  50nM</c:v>
                </c:pt>
              </c:strCache>
            </c:strRef>
          </c:cat>
          <c:val>
            <c:numRef>
              <c:f>'Results (2)'!$I$47:$I$49</c:f>
              <c:numCache>
                <c:formatCode>General</c:formatCode>
                <c:ptCount val="3"/>
                <c:pt idx="0">
                  <c:v>1.0007672816676039</c:v>
                </c:pt>
                <c:pt idx="1">
                  <c:v>0.44849026211853299</c:v>
                </c:pt>
                <c:pt idx="2">
                  <c:v>0.2123723298895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239-494C-954E-9DF7E72B097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91138800"/>
        <c:axId val="1391135888"/>
      </c:barChart>
      <c:catAx>
        <c:axId val="13911388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91135888"/>
        <c:crosses val="autoZero"/>
        <c:auto val="1"/>
        <c:lblAlgn val="ctr"/>
        <c:lblOffset val="100"/>
        <c:noMultiLvlLbl val="0"/>
      </c:catAx>
      <c:valAx>
        <c:axId val="139113588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ALOX 12 mRNA expression level</a:t>
                </a:r>
              </a:p>
              <a:p>
                <a:pPr>
                  <a:defRPr/>
                </a:pPr>
                <a:r>
                  <a:rPr lang="en-US" dirty="0"/>
                  <a:t>(fold increase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911388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1F770C-DD85-45C0-9E33-9F5DF22276D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65C03A9-EF00-42C7-87D0-17EFBC025FE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A357FA-8818-49C5-A51C-D95AE75971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12184-8D9B-424E-8A0D-EE2C413AE813}" type="datetimeFigureOut">
              <a:rPr lang="en-US" smtClean="0"/>
              <a:t>12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1FAA5D-A9EC-4115-A52C-3B4C51C4CE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D57BF7-60B5-466D-9A93-BAD390EC60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8B12E9-670F-47B3-B2FA-5EA86973BA7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5841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F72F1B-7183-4266-BFFA-DE66062C4F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EF835D2-639B-4065-B35F-98FAEA6F057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C71D81-F229-4892-86F5-EEC3147445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12184-8D9B-424E-8A0D-EE2C413AE813}" type="datetimeFigureOut">
              <a:rPr lang="en-US" smtClean="0"/>
              <a:t>12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12EF86-7DC5-42D5-8A60-5B80008130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4980D9-F2FA-44AA-AF09-B5F6C8C89F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8B12E9-670F-47B3-B2FA-5EA86973BA7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71736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FFAC06F-8CBE-4D65-A764-8040242210A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FE98186-03A4-4E96-8301-2FEEFFEE91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F711A9-898E-4840-9D40-A571DEEA37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12184-8D9B-424E-8A0D-EE2C413AE813}" type="datetimeFigureOut">
              <a:rPr lang="en-US" smtClean="0"/>
              <a:t>12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80F71C-733A-41F6-9CA5-3F5D6E87D9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F1FC52-277E-4C17-9111-BEEAC6BE26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8B12E9-670F-47B3-B2FA-5EA86973BA7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74845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D61F48-DF94-4C11-9B2A-858F2CB6AD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41F86BD-6FDB-43E0-A49F-3F586815993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DE0FA7C-BB34-468C-B0A7-4D1121DE39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12184-8D9B-424E-8A0D-EE2C413AE813}" type="datetimeFigureOut">
              <a:rPr lang="en-US" smtClean="0"/>
              <a:t>12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488B64-8A27-4742-B7CE-C74F40F4AA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B2BA99-EFF7-42B3-B7F3-B7FC93E307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8B12E9-670F-47B3-B2FA-5EA86973BA7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5148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D24576-1FE9-4196-95A5-9CE6874DF5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2301846-CE4A-437F-BFE8-2DC9AAB489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3BE916-4FDF-4C82-9B5F-2B6105BA3E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12184-8D9B-424E-8A0D-EE2C413AE813}" type="datetimeFigureOut">
              <a:rPr lang="en-US" smtClean="0"/>
              <a:t>12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774E08-3657-4053-9759-D7A47B40C1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B0AECA-885C-40DA-B6BE-7F5AE67B9D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8B12E9-670F-47B3-B2FA-5EA86973BA7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88979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A46EE2-B815-497B-91B1-B96C5463F2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4A61807-6826-4CD6-B375-5632A163CD1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4B566E9-115D-43C8-B9CE-A01D9B2879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CC8B739-A6A9-4119-BE3B-651C3ED679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12184-8D9B-424E-8A0D-EE2C413AE813}" type="datetimeFigureOut">
              <a:rPr lang="en-US" smtClean="0"/>
              <a:t>12/1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82587D0-462C-44D6-A5E7-C008241B81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95255E3-FBFB-46DB-B7A2-33938A981B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8B12E9-670F-47B3-B2FA-5EA86973BA7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87107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2BDA58-601F-4AC1-A2F6-8D2D024600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151796A-A440-4E8E-9938-D024BCA5B7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5E85EF2-9494-4A79-B2B1-C94D5F49F41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13DDC6F-B7F5-4EE7-8D79-FBFA444D528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A33103C-C69A-4BC5-BC53-089A0D050A2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64EA73E-993C-4091-87ED-35DAC00AD5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12184-8D9B-424E-8A0D-EE2C413AE813}" type="datetimeFigureOut">
              <a:rPr lang="en-US" smtClean="0"/>
              <a:t>12/16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4BCEC33-885D-4010-989D-9F14B7B560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F21C36D-7743-4C46-85C2-181E6C2DE7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8B12E9-670F-47B3-B2FA-5EA86973BA7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7094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F4EBDB-660E-4D35-8E3E-786CB61D08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3C18E67-0712-4ED2-AEE8-4DFB076A72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12184-8D9B-424E-8A0D-EE2C413AE813}" type="datetimeFigureOut">
              <a:rPr lang="en-US" smtClean="0"/>
              <a:t>12/16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9C33917-3768-4E62-92CE-611B676C4B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3B9392B-CCBE-410D-9C32-2289A7A3FC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8B12E9-670F-47B3-B2FA-5EA86973BA7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95734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86B0899-44DE-4E2F-B3F3-327C7C8D28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12184-8D9B-424E-8A0D-EE2C413AE813}" type="datetimeFigureOut">
              <a:rPr lang="en-US" smtClean="0"/>
              <a:t>12/16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8896621-38DD-463C-B94A-647DF02254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549CC0A-5431-402A-870C-CF9E3D48FF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8B12E9-670F-47B3-B2FA-5EA86973BA7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22274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15BC44-CCAE-4751-AF35-BE16AAE693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0AB16B9-B433-4930-989D-0154672294F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2E12E41-C2FC-4C37-BF38-8A6C7190BB2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E61AFC4-562E-49C1-BDCC-B8F28C60ED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12184-8D9B-424E-8A0D-EE2C413AE813}" type="datetimeFigureOut">
              <a:rPr lang="en-US" smtClean="0"/>
              <a:t>12/1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9527C61-F7BB-4DDC-921A-78AF2ED24C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ECB5DF8-F9C6-4776-8CA4-6B7C832345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8B12E9-670F-47B3-B2FA-5EA86973BA7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38226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851AEB-876D-43DF-8CF4-DA6ECAFAD9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927A86F-39BE-47F6-B32E-A3A38F54747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56262AC-6DE1-4203-AAA1-356B0D3B5EC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D5B5106-AB21-45DA-B523-2EAF43A4E6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F12184-8D9B-424E-8A0D-EE2C413AE813}" type="datetimeFigureOut">
              <a:rPr lang="en-US" smtClean="0"/>
              <a:t>12/1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3C79331-DA09-4A6F-84A8-9BFC0D8B88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0484D3C-13D7-441E-94DD-F2E745871E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8B12E9-670F-47B3-B2FA-5EA86973BA7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90059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68723AA-4526-43E4-B4C8-8F6A9A7C22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FB7A8E1-F61D-4BBF-8D4E-85A7425FCE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6CF5B5-976B-432A-94B7-45F56F89661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F12184-8D9B-424E-8A0D-EE2C413AE813}" type="datetimeFigureOut">
              <a:rPr lang="en-US" smtClean="0"/>
              <a:t>12/1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9F0DD6-77F2-44AC-82C9-FD1E4D1A4C2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29D51A-9208-4A3C-8A7C-7164EE51F91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8B12E9-670F-47B3-B2FA-5EA86973BA76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28615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D0DD01C9-B913-4A21-99A7-F47B41B6DA3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40063984"/>
              </p:ext>
            </p:extLst>
          </p:nvPr>
        </p:nvGraphicFramePr>
        <p:xfrm>
          <a:off x="1735493" y="987256"/>
          <a:ext cx="4189445" cy="27449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3B8F498E-599E-4911-878D-EA2753AB44F8}"/>
              </a:ext>
            </a:extLst>
          </p:cNvPr>
          <p:cNvSpPr txBox="1"/>
          <p:nvPr/>
        </p:nvSpPr>
        <p:spPr>
          <a:xfrm>
            <a:off x="1266824" y="3900025"/>
            <a:ext cx="10368642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>
                <a:latin typeface="Palatino Linotype" panose="02040502050505030304" pitchFamily="18" charset="0"/>
              </a:rPr>
              <a:t>Supplementary Figure S1.</a:t>
            </a:r>
            <a:r>
              <a:rPr lang="en-US" dirty="0">
                <a:latin typeface="Palatino Linotype" panose="02040502050505030304" pitchFamily="18" charset="0"/>
              </a:rPr>
              <a:t>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rataxin levels in knocked-down cells. </a:t>
            </a:r>
            <a:r>
              <a:rPr lang="en-US" dirty="0">
                <a:latin typeface="Palatino Linotype" panose="02040502050505030304" pitchFamily="18" charset="0"/>
              </a:rPr>
              <a:t>Frataxin protein levels measured by ELISA in primary, apparently healthy fibroblasts (Coriell 8400) transfected with an siRNA against frataxin or with a scrambled control. 0.5 µM PCA was added at day 2, 4 and 5 post-transfection and protein was measured at day 6. </a:t>
            </a:r>
            <a:r>
              <a:rPr lang="en-US" sz="1800" kern="150" dirty="0" err="1"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sc</a:t>
            </a:r>
            <a:r>
              <a:rPr lang="en-US" sz="1800" kern="150" dirty="0"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=scrambled siRNA; </a:t>
            </a:r>
            <a:r>
              <a:rPr lang="en-US" sz="1800" kern="150" dirty="0" err="1"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sifxn</a:t>
            </a:r>
            <a:r>
              <a:rPr lang="en-US" sz="1800" kern="150" dirty="0"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=anti-</a:t>
            </a:r>
            <a:r>
              <a:rPr lang="en-US" kern="150" dirty="0" err="1">
                <a:latin typeface="Palatino Linotype" panose="0204050205050503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F</a:t>
            </a:r>
            <a:r>
              <a:rPr lang="en-US" sz="1800" kern="150" dirty="0" err="1"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xn</a:t>
            </a:r>
            <a:r>
              <a:rPr lang="en-US" sz="1800" kern="150" dirty="0"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 siRNA. ***=</a:t>
            </a:r>
            <a:r>
              <a:rPr lang="en-US" sz="1800" i="1" kern="150" dirty="0"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sz="1800" kern="150" dirty="0"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&lt;0.005 by 2-sided </a:t>
            </a:r>
            <a:r>
              <a:rPr lang="en-US" sz="1800" i="1" kern="150" dirty="0"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t</a:t>
            </a:r>
            <a:r>
              <a:rPr lang="en-US" sz="1800" kern="150" dirty="0"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 test.</a:t>
            </a:r>
            <a:r>
              <a:rPr lang="en-US" kern="150" dirty="0">
                <a:latin typeface="Palatino Linotype" panose="0204050205050503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sz="1800" kern="150" dirty="0"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The data show the average and the SD calculated from three independent replicates. </a:t>
            </a:r>
            <a:endParaRPr lang="en-US" dirty="0">
              <a:latin typeface="Palatino Linotype" panose="02040502050505030304" pitchFamily="18" charset="0"/>
            </a:endParaRP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A7394046-4378-4A7C-B7EB-89E2655D88A0}"/>
              </a:ext>
            </a:extLst>
          </p:cNvPr>
          <p:cNvCxnSpPr/>
          <p:nvPr/>
        </p:nvCxnSpPr>
        <p:spPr>
          <a:xfrm>
            <a:off x="3032449" y="1203649"/>
            <a:ext cx="108235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791F6F83-6EC3-4D7B-AACF-7CD89189B27F}"/>
              </a:ext>
            </a:extLst>
          </p:cNvPr>
          <p:cNvSpPr txBox="1"/>
          <p:nvPr/>
        </p:nvSpPr>
        <p:spPr>
          <a:xfrm>
            <a:off x="3299300" y="976136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**</a:t>
            </a: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D7B3BE97-3D81-4653-835A-DF4DEB063658}"/>
              </a:ext>
            </a:extLst>
          </p:cNvPr>
          <p:cNvCxnSpPr/>
          <p:nvPr/>
        </p:nvCxnSpPr>
        <p:spPr>
          <a:xfrm>
            <a:off x="3032449" y="720239"/>
            <a:ext cx="231399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6C5A02C8-7364-43E1-9971-11E3505C659B}"/>
              </a:ext>
            </a:extLst>
          </p:cNvPr>
          <p:cNvSpPr txBox="1"/>
          <p:nvPr/>
        </p:nvSpPr>
        <p:spPr>
          <a:xfrm>
            <a:off x="3830215" y="463969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**</a:t>
            </a:r>
          </a:p>
        </p:txBody>
      </p:sp>
    </p:spTree>
    <p:extLst>
      <p:ext uri="{BB962C8B-B14F-4D97-AF65-F5344CB8AC3E}">
        <p14:creationId xmlns:p14="http://schemas.microsoft.com/office/powerpoint/2010/main" val="29587774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6F69BA3F-5EEF-40E3-A5FC-A962D698461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18631034"/>
              </p:ext>
            </p:extLst>
          </p:nvPr>
        </p:nvGraphicFramePr>
        <p:xfrm>
          <a:off x="1939214" y="939864"/>
          <a:ext cx="3181348" cy="30956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0E33E8F5-E320-442C-8852-D93711C3B29C}"/>
              </a:ext>
            </a:extLst>
          </p:cNvPr>
          <p:cNvCxnSpPr/>
          <p:nvPr/>
        </p:nvCxnSpPr>
        <p:spPr>
          <a:xfrm>
            <a:off x="3032449" y="1156996"/>
            <a:ext cx="83975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B62A5B17-CB8D-4D96-B29B-BBC9BE72EE84}"/>
              </a:ext>
            </a:extLst>
          </p:cNvPr>
          <p:cNvSpPr txBox="1"/>
          <p:nvPr/>
        </p:nvSpPr>
        <p:spPr>
          <a:xfrm>
            <a:off x="3124783" y="853751"/>
            <a:ext cx="91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***</a:t>
            </a:r>
          </a:p>
        </p:txBody>
      </p: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65B0D5E0-8D91-4B37-B59F-C7D245075E44}"/>
              </a:ext>
            </a:extLst>
          </p:cNvPr>
          <p:cNvCxnSpPr>
            <a:cxnSpLocks/>
          </p:cNvCxnSpPr>
          <p:nvPr/>
        </p:nvCxnSpPr>
        <p:spPr>
          <a:xfrm>
            <a:off x="3022146" y="853751"/>
            <a:ext cx="157784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F1DF12AD-C3CF-43BD-BEBD-1E7C84941AE2}"/>
              </a:ext>
            </a:extLst>
          </p:cNvPr>
          <p:cNvSpPr txBox="1"/>
          <p:nvPr/>
        </p:nvSpPr>
        <p:spPr>
          <a:xfrm>
            <a:off x="3581983" y="570532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**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B5A67DB-F6C3-42D4-BD08-96794623AAE8}"/>
              </a:ext>
            </a:extLst>
          </p:cNvPr>
          <p:cNvSpPr txBox="1"/>
          <p:nvPr/>
        </p:nvSpPr>
        <p:spPr>
          <a:xfrm>
            <a:off x="1147527" y="4249923"/>
            <a:ext cx="1066426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Palatino Linotype" panose="02040502050505030304" pitchFamily="18" charset="0"/>
              </a:rPr>
              <a:t>Supplementary Figure S2.</a:t>
            </a:r>
            <a:r>
              <a:rPr lang="en-US" dirty="0">
                <a:latin typeface="Palatino Linotype" panose="02040502050505030304" pitchFamily="18" charset="0"/>
              </a:rPr>
              <a:t>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LOX12 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RNA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levels in FRDA 4497 cells. </a:t>
            </a:r>
            <a:r>
              <a:rPr lang="en-US" dirty="0">
                <a:latin typeface="Palatino Linotype" panose="02040502050505030304" pitchFamily="18" charset="0"/>
              </a:rPr>
              <a:t>Primary FRDA fibroblasts (FRDA Cell Line  Repository 4497) were treated for 24 h with 0.5 µM PCA or 50 </a:t>
            </a:r>
            <a:r>
              <a:rPr lang="en-US" dirty="0" err="1">
                <a:latin typeface="Palatino Linotype" panose="02040502050505030304" pitchFamily="18" charset="0"/>
              </a:rPr>
              <a:t>nM</a:t>
            </a:r>
            <a:r>
              <a:rPr lang="en-US" dirty="0">
                <a:latin typeface="Palatino Linotype" panose="02040502050505030304" pitchFamily="18" charset="0"/>
              </a:rPr>
              <a:t> Omav. The following day, RNA was extracted and ALOX12 expression was measured relative to TBP (TATA Binding protein). CC = carrier Control; </a:t>
            </a:r>
            <a:r>
              <a:rPr lang="en-US" sz="1800" kern="150" dirty="0"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***=</a:t>
            </a:r>
            <a:r>
              <a:rPr lang="en-US" sz="1800" i="1" kern="150" dirty="0"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sz="1800" kern="150" dirty="0"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&lt;0.005 by two-sided </a:t>
            </a:r>
            <a:r>
              <a:rPr lang="en-US" sz="1800" i="1" kern="150" dirty="0"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t</a:t>
            </a:r>
            <a:r>
              <a:rPr lang="en-US" sz="1800" kern="150" dirty="0">
                <a:effectLst/>
                <a:latin typeface="Palatino Linotype" panose="0204050205050503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 test. The data show the average and the SD  calculated from three replicates.</a:t>
            </a:r>
            <a:endParaRPr lang="en-US" dirty="0">
              <a:latin typeface="Palatino Linotype" panose="02040502050505030304" pitchFamily="18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765477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4</TotalTime>
  <Words>194</Words>
  <Application>Microsoft Office PowerPoint</Application>
  <PresentationFormat>Widescreen</PresentationFormat>
  <Paragraphs>9</Paragraphs>
  <Slides>2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Office Theme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a Cotticelli</dc:creator>
  <cp:lastModifiedBy>Hp</cp:lastModifiedBy>
  <cp:revision>19</cp:revision>
  <dcterms:created xsi:type="dcterms:W3CDTF">2025-10-06T02:58:19Z</dcterms:created>
  <dcterms:modified xsi:type="dcterms:W3CDTF">2025-12-16T18:37:45Z</dcterms:modified>
</cp:coreProperties>
</file>